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58" r:id="rId5"/>
    <p:sldId id="261" r:id="rId6"/>
    <p:sldId id="259" r:id="rId7"/>
    <p:sldId id="262" r:id="rId8"/>
    <p:sldId id="264" r:id="rId9"/>
    <p:sldId id="267" r:id="rId10"/>
    <p:sldId id="263" r:id="rId11"/>
    <p:sldId id="265" r:id="rId12"/>
    <p:sldId id="266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E0D123B-F41D-4CEB-96EF-57DD03D6ADF9}" v="20" dt="2026-02-23T15:25:35.27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8" d="100"/>
          <a:sy n="48" d="100"/>
        </p:scale>
        <p:origin x="53" y="7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ji, Lukmon" userId="e0eacb11-e3cd-45f2-822c-68ccd699b297" providerId="ADAL" clId="{E77DA156-CF69-41F5-840F-366CE602D449}"/>
    <pc:docChg chg="undo custSel addSld delSld modSld sldOrd">
      <pc:chgData name="Raji, Lukmon" userId="e0eacb11-e3cd-45f2-822c-68ccd699b297" providerId="ADAL" clId="{E77DA156-CF69-41F5-840F-366CE602D449}" dt="2026-02-23T15:25:40.234" v="573" actId="1076"/>
      <pc:docMkLst>
        <pc:docMk/>
      </pc:docMkLst>
      <pc:sldChg chg="delSp modSp new mod">
        <pc:chgData name="Raji, Lukmon" userId="e0eacb11-e3cd-45f2-822c-68ccd699b297" providerId="ADAL" clId="{E77DA156-CF69-41F5-840F-366CE602D449}" dt="2026-02-21T00:59:29.367" v="5" actId="478"/>
        <pc:sldMkLst>
          <pc:docMk/>
          <pc:sldMk cId="2128084088" sldId="256"/>
        </pc:sldMkLst>
        <pc:spChg chg="mod">
          <ac:chgData name="Raji, Lukmon" userId="e0eacb11-e3cd-45f2-822c-68ccd699b297" providerId="ADAL" clId="{E77DA156-CF69-41F5-840F-366CE602D449}" dt="2026-02-21T00:59:25.704" v="4" actId="20577"/>
          <ac:spMkLst>
            <pc:docMk/>
            <pc:sldMk cId="2128084088" sldId="256"/>
            <ac:spMk id="2" creationId="{607A36E7-F29D-AE3D-256E-1C6F77CEF28D}"/>
          </ac:spMkLst>
        </pc:spChg>
      </pc:sldChg>
      <pc:sldChg chg="addSp delSp modSp new mod">
        <pc:chgData name="Raji, Lukmon" userId="e0eacb11-e3cd-45f2-822c-68ccd699b297" providerId="ADAL" clId="{E77DA156-CF69-41F5-840F-366CE602D449}" dt="2026-02-21T03:37:11.321" v="163" actId="20577"/>
        <pc:sldMkLst>
          <pc:docMk/>
          <pc:sldMk cId="987100644" sldId="257"/>
        </pc:sldMkLst>
        <pc:spChg chg="add mod">
          <ac:chgData name="Raji, Lukmon" userId="e0eacb11-e3cd-45f2-822c-68ccd699b297" providerId="ADAL" clId="{E77DA156-CF69-41F5-840F-366CE602D449}" dt="2026-02-21T02:59:12.916" v="139" actId="255"/>
          <ac:spMkLst>
            <pc:docMk/>
            <pc:sldMk cId="987100644" sldId="257"/>
            <ac:spMk id="6" creationId="{E6B1069D-7381-7A0B-32F7-161C63EB51AD}"/>
          </ac:spMkLst>
        </pc:spChg>
        <pc:spChg chg="add mod">
          <ac:chgData name="Raji, Lukmon" userId="e0eacb11-e3cd-45f2-822c-68ccd699b297" providerId="ADAL" clId="{E77DA156-CF69-41F5-840F-366CE602D449}" dt="2026-02-21T03:37:11.321" v="163" actId="20577"/>
          <ac:spMkLst>
            <pc:docMk/>
            <pc:sldMk cId="987100644" sldId="257"/>
            <ac:spMk id="7" creationId="{75CDE60E-0486-5234-5A5A-D4339C18FA46}"/>
          </ac:spMkLst>
        </pc:spChg>
        <pc:picChg chg="add mod">
          <ac:chgData name="Raji, Lukmon" userId="e0eacb11-e3cd-45f2-822c-68ccd699b297" providerId="ADAL" clId="{E77DA156-CF69-41F5-840F-366CE602D449}" dt="2026-02-21T01:04:18.329" v="43" actId="1076"/>
          <ac:picMkLst>
            <pc:docMk/>
            <pc:sldMk cId="987100644" sldId="257"/>
            <ac:picMk id="5" creationId="{2E0B068E-39CB-0D1E-BC15-66E4B783BA31}"/>
          </ac:picMkLst>
        </pc:picChg>
      </pc:sldChg>
      <pc:sldChg chg="addSp modSp add mod">
        <pc:chgData name="Raji, Lukmon" userId="e0eacb11-e3cd-45f2-822c-68ccd699b297" providerId="ADAL" clId="{E77DA156-CF69-41F5-840F-366CE602D449}" dt="2026-02-21T03:38:00.041" v="192" actId="14100"/>
        <pc:sldMkLst>
          <pc:docMk/>
          <pc:sldMk cId="3261007478" sldId="258"/>
        </pc:sldMkLst>
        <pc:spChg chg="add mod">
          <ac:chgData name="Raji, Lukmon" userId="e0eacb11-e3cd-45f2-822c-68ccd699b297" providerId="ADAL" clId="{E77DA156-CF69-41F5-840F-366CE602D449}" dt="2026-02-21T03:38:00.041" v="192" actId="14100"/>
          <ac:spMkLst>
            <pc:docMk/>
            <pc:sldMk cId="3261007478" sldId="258"/>
            <ac:spMk id="4" creationId="{04B0BFFD-E67A-F7BF-1335-A7D685F57C40}"/>
          </ac:spMkLst>
        </pc:spChg>
        <pc:picChg chg="add mod">
          <ac:chgData name="Raji, Lukmon" userId="e0eacb11-e3cd-45f2-822c-68ccd699b297" providerId="ADAL" clId="{E77DA156-CF69-41F5-840F-366CE602D449}" dt="2026-02-21T03:37:27.915" v="165"/>
          <ac:picMkLst>
            <pc:docMk/>
            <pc:sldMk cId="3261007478" sldId="258"/>
            <ac:picMk id="3" creationId="{4B1962BF-5206-FDE2-3C92-43A4B35FFBE1}"/>
          </ac:picMkLst>
        </pc:picChg>
      </pc:sldChg>
      <pc:sldChg chg="addSp delSp modSp add mod ord">
        <pc:chgData name="Raji, Lukmon" userId="e0eacb11-e3cd-45f2-822c-68ccd699b297" providerId="ADAL" clId="{E77DA156-CF69-41F5-840F-366CE602D449}" dt="2026-02-23T15:23:01.919" v="559" actId="1076"/>
        <pc:sldMkLst>
          <pc:docMk/>
          <pc:sldMk cId="2713148813" sldId="259"/>
        </pc:sldMkLst>
        <pc:spChg chg="add mod">
          <ac:chgData name="Raji, Lukmon" userId="e0eacb11-e3cd-45f2-822c-68ccd699b297" providerId="ADAL" clId="{E77DA156-CF69-41F5-840F-366CE602D449}" dt="2026-02-21T05:49:18.095" v="214" actId="20577"/>
          <ac:spMkLst>
            <pc:docMk/>
            <pc:sldMk cId="2713148813" sldId="259"/>
            <ac:spMk id="2" creationId="{5AA1869F-CC2C-BBBB-C20A-932904288687}"/>
          </ac:spMkLst>
        </pc:spChg>
        <pc:spChg chg="add mod">
          <ac:chgData name="Raji, Lukmon" userId="e0eacb11-e3cd-45f2-822c-68ccd699b297" providerId="ADAL" clId="{E77DA156-CF69-41F5-840F-366CE602D449}" dt="2026-02-23T15:23:01.919" v="559" actId="1076"/>
          <ac:spMkLst>
            <pc:docMk/>
            <pc:sldMk cId="2713148813" sldId="259"/>
            <ac:spMk id="3" creationId="{9259D8AB-1BA2-9C15-DB4C-3F9562C47A89}"/>
          </ac:spMkLst>
        </pc:spChg>
        <pc:spChg chg="add mod">
          <ac:chgData name="Raji, Lukmon" userId="e0eacb11-e3cd-45f2-822c-68ccd699b297" providerId="ADAL" clId="{E77DA156-CF69-41F5-840F-366CE602D449}" dt="2026-02-21T07:26:37.998" v="305" actId="20577"/>
          <ac:spMkLst>
            <pc:docMk/>
            <pc:sldMk cId="2713148813" sldId="259"/>
            <ac:spMk id="7" creationId="{41D368BD-3B29-5ABD-9F61-2AD75E562571}"/>
          </ac:spMkLst>
        </pc:spChg>
        <pc:picChg chg="add mod">
          <ac:chgData name="Raji, Lukmon" userId="e0eacb11-e3cd-45f2-822c-68ccd699b297" providerId="ADAL" clId="{E77DA156-CF69-41F5-840F-366CE602D449}" dt="2026-02-21T05:49:39.894" v="228" actId="14100"/>
          <ac:picMkLst>
            <pc:docMk/>
            <pc:sldMk cId="2713148813" sldId="259"/>
            <ac:picMk id="6" creationId="{6902D1AC-109F-B0F7-64CB-4B7E8C241090}"/>
          </ac:picMkLst>
        </pc:picChg>
      </pc:sldChg>
      <pc:sldChg chg="addSp delSp modSp add mod">
        <pc:chgData name="Raji, Lukmon" userId="e0eacb11-e3cd-45f2-822c-68ccd699b297" providerId="ADAL" clId="{E77DA156-CF69-41F5-840F-366CE602D449}" dt="2026-02-21T03:32:16.265" v="155" actId="20577"/>
        <pc:sldMkLst>
          <pc:docMk/>
          <pc:sldMk cId="2299598248" sldId="260"/>
        </pc:sldMkLst>
        <pc:spChg chg="mod">
          <ac:chgData name="Raji, Lukmon" userId="e0eacb11-e3cd-45f2-822c-68ccd699b297" providerId="ADAL" clId="{E77DA156-CF69-41F5-840F-366CE602D449}" dt="2026-02-21T02:58:55.634" v="137" actId="255"/>
          <ac:spMkLst>
            <pc:docMk/>
            <pc:sldMk cId="2299598248" sldId="260"/>
            <ac:spMk id="6" creationId="{EE49A9D4-1E43-820F-8612-CE27EDDC529D}"/>
          </ac:spMkLst>
        </pc:spChg>
        <pc:spChg chg="mod">
          <ac:chgData name="Raji, Lukmon" userId="e0eacb11-e3cd-45f2-822c-68ccd699b297" providerId="ADAL" clId="{E77DA156-CF69-41F5-840F-366CE602D449}" dt="2026-02-21T03:32:16.265" v="155" actId="20577"/>
          <ac:spMkLst>
            <pc:docMk/>
            <pc:sldMk cId="2299598248" sldId="260"/>
            <ac:spMk id="7" creationId="{415A846F-B1EC-3BA1-BCFE-2DF1E84B0EF0}"/>
          </ac:spMkLst>
        </pc:spChg>
        <pc:picChg chg="add mod ord">
          <ac:chgData name="Raji, Lukmon" userId="e0eacb11-e3cd-45f2-822c-68ccd699b297" providerId="ADAL" clId="{E77DA156-CF69-41F5-840F-366CE602D449}" dt="2026-02-21T02:38:14.672" v="102" actId="167"/>
          <ac:picMkLst>
            <pc:docMk/>
            <pc:sldMk cId="2299598248" sldId="260"/>
            <ac:picMk id="3" creationId="{5C6B9033-51A6-2A9B-5923-408FE2E25FEF}"/>
          </ac:picMkLst>
        </pc:picChg>
      </pc:sldChg>
      <pc:sldChg chg="modSp add mod ord">
        <pc:chgData name="Raji, Lukmon" userId="e0eacb11-e3cd-45f2-822c-68ccd699b297" providerId="ADAL" clId="{E77DA156-CF69-41F5-840F-366CE602D449}" dt="2026-02-21T03:40:24.177" v="198" actId="20577"/>
        <pc:sldMkLst>
          <pc:docMk/>
          <pc:sldMk cId="1362433513" sldId="261"/>
        </pc:sldMkLst>
        <pc:spChg chg="mod">
          <ac:chgData name="Raji, Lukmon" userId="e0eacb11-e3cd-45f2-822c-68ccd699b297" providerId="ADAL" clId="{E77DA156-CF69-41F5-840F-366CE602D449}" dt="2026-02-21T03:40:24.177" v="198" actId="20577"/>
          <ac:spMkLst>
            <pc:docMk/>
            <pc:sldMk cId="1362433513" sldId="261"/>
            <ac:spMk id="2" creationId="{523A4D10-1FF4-D998-4BCD-E76DD3720A70}"/>
          </ac:spMkLst>
        </pc:spChg>
      </pc:sldChg>
      <pc:sldChg chg="addSp delSp modSp new mod ord">
        <pc:chgData name="Raji, Lukmon" userId="e0eacb11-e3cd-45f2-822c-68ccd699b297" providerId="ADAL" clId="{E77DA156-CF69-41F5-840F-366CE602D449}" dt="2026-02-23T15:23:25.385" v="561" actId="1076"/>
        <pc:sldMkLst>
          <pc:docMk/>
          <pc:sldMk cId="2125985125" sldId="262"/>
        </pc:sldMkLst>
        <pc:spChg chg="add mod">
          <ac:chgData name="Raji, Lukmon" userId="e0eacb11-e3cd-45f2-822c-68ccd699b297" providerId="ADAL" clId="{E77DA156-CF69-41F5-840F-366CE602D449}" dt="2026-02-23T15:23:25.385" v="561" actId="1076"/>
          <ac:spMkLst>
            <pc:docMk/>
            <pc:sldMk cId="2125985125" sldId="262"/>
            <ac:spMk id="2" creationId="{8A8BB45E-6997-CD5A-5A7C-15E81ACED050}"/>
          </ac:spMkLst>
        </pc:spChg>
        <pc:spChg chg="add mod">
          <ac:chgData name="Raji, Lukmon" userId="e0eacb11-e3cd-45f2-822c-68ccd699b297" providerId="ADAL" clId="{E77DA156-CF69-41F5-840F-366CE602D449}" dt="2026-02-21T07:31:04.106" v="345" actId="20577"/>
          <ac:spMkLst>
            <pc:docMk/>
            <pc:sldMk cId="2125985125" sldId="262"/>
            <ac:spMk id="6" creationId="{41B928ED-52C9-ADD1-597B-BD6CF53B0F72}"/>
          </ac:spMkLst>
        </pc:spChg>
        <pc:spChg chg="add mod">
          <ac:chgData name="Raji, Lukmon" userId="e0eacb11-e3cd-45f2-822c-68ccd699b297" providerId="ADAL" clId="{E77DA156-CF69-41F5-840F-366CE602D449}" dt="2026-02-21T07:05:14.291" v="237" actId="20577"/>
          <ac:spMkLst>
            <pc:docMk/>
            <pc:sldMk cId="2125985125" sldId="262"/>
            <ac:spMk id="8" creationId="{666FBDC0-6BF3-0728-0C40-A4E40C7139A9}"/>
          </ac:spMkLst>
        </pc:spChg>
        <pc:picChg chg="add mod">
          <ac:chgData name="Raji, Lukmon" userId="e0eacb11-e3cd-45f2-822c-68ccd699b297" providerId="ADAL" clId="{E77DA156-CF69-41F5-840F-366CE602D449}" dt="2026-02-21T07:27:40.248" v="308" actId="14100"/>
          <ac:picMkLst>
            <pc:docMk/>
            <pc:sldMk cId="2125985125" sldId="262"/>
            <ac:picMk id="5" creationId="{55DE9FEE-D6AF-6D49-421D-2EBC2294582C}"/>
          </ac:picMkLst>
        </pc:picChg>
      </pc:sldChg>
      <pc:sldChg chg="addSp modSp add mod ord">
        <pc:chgData name="Raji, Lukmon" userId="e0eacb11-e3cd-45f2-822c-68ccd699b297" providerId="ADAL" clId="{E77DA156-CF69-41F5-840F-366CE602D449}" dt="2026-02-23T15:25:22.863" v="569" actId="1076"/>
        <pc:sldMkLst>
          <pc:docMk/>
          <pc:sldMk cId="17337917" sldId="263"/>
        </pc:sldMkLst>
        <pc:spChg chg="add mod">
          <ac:chgData name="Raji, Lukmon" userId="e0eacb11-e3cd-45f2-822c-68ccd699b297" providerId="ADAL" clId="{E77DA156-CF69-41F5-840F-366CE602D449}" dt="2026-02-23T15:25:22.863" v="569" actId="1076"/>
          <ac:spMkLst>
            <pc:docMk/>
            <pc:sldMk cId="17337917" sldId="263"/>
            <ac:spMk id="2" creationId="{9BA9EECB-538C-726A-9724-7FB6625E34C6}"/>
          </ac:spMkLst>
        </pc:spChg>
        <pc:spChg chg="add mod">
          <ac:chgData name="Raji, Lukmon" userId="e0eacb11-e3cd-45f2-822c-68ccd699b297" providerId="ADAL" clId="{E77DA156-CF69-41F5-840F-366CE602D449}" dt="2026-02-22T22:51:41.053" v="387" actId="1076"/>
          <ac:spMkLst>
            <pc:docMk/>
            <pc:sldMk cId="17337917" sldId="263"/>
            <ac:spMk id="4" creationId="{B0B5398A-08B4-23FD-C021-9B21A03E84DA}"/>
          </ac:spMkLst>
        </pc:spChg>
        <pc:spChg chg="add mod">
          <ac:chgData name="Raji, Lukmon" userId="e0eacb11-e3cd-45f2-822c-68ccd699b297" providerId="ADAL" clId="{E77DA156-CF69-41F5-840F-366CE602D449}" dt="2026-02-22T23:06:36.084" v="450" actId="20577"/>
          <ac:spMkLst>
            <pc:docMk/>
            <pc:sldMk cId="17337917" sldId="263"/>
            <ac:spMk id="5" creationId="{969A25B2-1AAE-AA91-09E9-83970BD986F9}"/>
          </ac:spMkLst>
        </pc:spChg>
        <pc:picChg chg="add mod">
          <ac:chgData name="Raji, Lukmon" userId="e0eacb11-e3cd-45f2-822c-68ccd699b297" providerId="ADAL" clId="{E77DA156-CF69-41F5-840F-366CE602D449}" dt="2026-02-22T23:05:35.129" v="421" actId="1076"/>
          <ac:picMkLst>
            <pc:docMk/>
            <pc:sldMk cId="17337917" sldId="263"/>
            <ac:picMk id="3" creationId="{65C230AA-A6D4-D7F4-D183-79E9667A003F}"/>
          </ac:picMkLst>
        </pc:picChg>
      </pc:sldChg>
      <pc:sldChg chg="addSp modSp add mod">
        <pc:chgData name="Raji, Lukmon" userId="e0eacb11-e3cd-45f2-822c-68ccd699b297" providerId="ADAL" clId="{E77DA156-CF69-41F5-840F-366CE602D449}" dt="2026-02-23T15:23:41.627" v="567" actId="20577"/>
        <pc:sldMkLst>
          <pc:docMk/>
          <pc:sldMk cId="1834325420" sldId="264"/>
        </pc:sldMkLst>
        <pc:spChg chg="add mod">
          <ac:chgData name="Raji, Lukmon" userId="e0eacb11-e3cd-45f2-822c-68ccd699b297" providerId="ADAL" clId="{E77DA156-CF69-41F5-840F-366CE602D449}" dt="2026-02-23T15:23:41.627" v="567" actId="20577"/>
          <ac:spMkLst>
            <pc:docMk/>
            <pc:sldMk cId="1834325420" sldId="264"/>
            <ac:spMk id="3" creationId="{033B0C17-7FE4-31DE-6CF7-7D24B68C55B2}"/>
          </ac:spMkLst>
        </pc:spChg>
      </pc:sldChg>
      <pc:sldChg chg="addSp modSp add mod">
        <pc:chgData name="Raji, Lukmon" userId="e0eacb11-e3cd-45f2-822c-68ccd699b297" providerId="ADAL" clId="{E77DA156-CF69-41F5-840F-366CE602D449}" dt="2026-02-23T15:25:32.459" v="571" actId="1076"/>
        <pc:sldMkLst>
          <pc:docMk/>
          <pc:sldMk cId="1452391635" sldId="265"/>
        </pc:sldMkLst>
        <pc:spChg chg="add mod">
          <ac:chgData name="Raji, Lukmon" userId="e0eacb11-e3cd-45f2-822c-68ccd699b297" providerId="ADAL" clId="{E77DA156-CF69-41F5-840F-366CE602D449}" dt="2026-02-22T22:52:02.629" v="393" actId="20577"/>
          <ac:spMkLst>
            <pc:docMk/>
            <pc:sldMk cId="1452391635" sldId="265"/>
            <ac:spMk id="2" creationId="{E3C7FBBB-C5D0-7BB7-15F0-B46D6EFEC7A2}"/>
          </ac:spMkLst>
        </pc:spChg>
        <pc:spChg chg="add mod">
          <ac:chgData name="Raji, Lukmon" userId="e0eacb11-e3cd-45f2-822c-68ccd699b297" providerId="ADAL" clId="{E77DA156-CF69-41F5-840F-366CE602D449}" dt="2026-02-23T15:25:32.459" v="571" actId="1076"/>
          <ac:spMkLst>
            <pc:docMk/>
            <pc:sldMk cId="1452391635" sldId="265"/>
            <ac:spMk id="3" creationId="{FC89D727-B5A5-D2CE-3F18-20CB91637BFA}"/>
          </ac:spMkLst>
        </pc:spChg>
        <pc:spChg chg="add mod">
          <ac:chgData name="Raji, Lukmon" userId="e0eacb11-e3cd-45f2-822c-68ccd699b297" providerId="ADAL" clId="{E77DA156-CF69-41F5-840F-366CE602D449}" dt="2026-02-22T23:11:35.732" v="503" actId="20577"/>
          <ac:spMkLst>
            <pc:docMk/>
            <pc:sldMk cId="1452391635" sldId="265"/>
            <ac:spMk id="5" creationId="{920A4825-7136-EF65-1657-E2CFD0E5380B}"/>
          </ac:spMkLst>
        </pc:spChg>
        <pc:picChg chg="add mod">
          <ac:chgData name="Raji, Lukmon" userId="e0eacb11-e3cd-45f2-822c-68ccd699b297" providerId="ADAL" clId="{E77DA156-CF69-41F5-840F-366CE602D449}" dt="2026-02-22T22:52:25.533" v="396" actId="14100"/>
          <ac:picMkLst>
            <pc:docMk/>
            <pc:sldMk cId="1452391635" sldId="265"/>
            <ac:picMk id="4" creationId="{9858D2E3-ACBF-842D-F9D2-D4DEFAFB7E3F}"/>
          </ac:picMkLst>
        </pc:picChg>
      </pc:sldChg>
      <pc:sldChg chg="new del">
        <pc:chgData name="Raji, Lukmon" userId="e0eacb11-e3cd-45f2-822c-68ccd699b297" providerId="ADAL" clId="{E77DA156-CF69-41F5-840F-366CE602D449}" dt="2026-02-22T22:45:22.692" v="347" actId="680"/>
        <pc:sldMkLst>
          <pc:docMk/>
          <pc:sldMk cId="4195865847" sldId="265"/>
        </pc:sldMkLst>
      </pc:sldChg>
      <pc:sldChg chg="addSp modSp add mod">
        <pc:chgData name="Raji, Lukmon" userId="e0eacb11-e3cd-45f2-822c-68ccd699b297" providerId="ADAL" clId="{E77DA156-CF69-41F5-840F-366CE602D449}" dt="2026-02-23T15:25:40.234" v="573" actId="1076"/>
        <pc:sldMkLst>
          <pc:docMk/>
          <pc:sldMk cId="3370883280" sldId="266"/>
        </pc:sldMkLst>
        <pc:spChg chg="add mod">
          <ac:chgData name="Raji, Lukmon" userId="e0eacb11-e3cd-45f2-822c-68ccd699b297" providerId="ADAL" clId="{E77DA156-CF69-41F5-840F-366CE602D449}" dt="2026-02-23T15:25:40.234" v="573" actId="1076"/>
          <ac:spMkLst>
            <pc:docMk/>
            <pc:sldMk cId="3370883280" sldId="266"/>
            <ac:spMk id="2" creationId="{CC027925-05B9-84F0-1C94-4870376CE1F5}"/>
          </ac:spMkLst>
        </pc:spChg>
        <pc:spChg chg="add mod">
          <ac:chgData name="Raji, Lukmon" userId="e0eacb11-e3cd-45f2-822c-68ccd699b297" providerId="ADAL" clId="{E77DA156-CF69-41F5-840F-366CE602D449}" dt="2026-02-22T22:46:51.784" v="364" actId="20577"/>
          <ac:spMkLst>
            <pc:docMk/>
            <pc:sldMk cId="3370883280" sldId="266"/>
            <ac:spMk id="4" creationId="{B5F105DE-D3FD-1808-9AFF-8758D28A4EB6}"/>
          </ac:spMkLst>
        </pc:spChg>
        <pc:picChg chg="add mod">
          <ac:chgData name="Raji, Lukmon" userId="e0eacb11-e3cd-45f2-822c-68ccd699b297" providerId="ADAL" clId="{E77DA156-CF69-41F5-840F-366CE602D449}" dt="2026-02-22T22:46:32.553" v="352" actId="14100"/>
          <ac:picMkLst>
            <pc:docMk/>
            <pc:sldMk cId="3370883280" sldId="266"/>
            <ac:picMk id="3" creationId="{764F784C-57FB-5943-3FF9-E9E7B1C868BE}"/>
          </ac:picMkLst>
        </pc:picChg>
      </pc:sldChg>
      <pc:sldChg chg="new del">
        <pc:chgData name="Raji, Lukmon" userId="e0eacb11-e3cd-45f2-822c-68ccd699b297" providerId="ADAL" clId="{E77DA156-CF69-41F5-840F-366CE602D449}" dt="2026-02-22T22:50:24.170" v="366" actId="680"/>
        <pc:sldMkLst>
          <pc:docMk/>
          <pc:sldMk cId="1716286340" sldId="267"/>
        </pc:sldMkLst>
      </pc:sldChg>
      <pc:sldChg chg="modSp add mod ord">
        <pc:chgData name="Raji, Lukmon" userId="e0eacb11-e3cd-45f2-822c-68ccd699b297" providerId="ADAL" clId="{E77DA156-CF69-41F5-840F-366CE602D449}" dt="2026-02-22T22:50:45.657" v="377" actId="20577"/>
        <pc:sldMkLst>
          <pc:docMk/>
          <pc:sldMk cId="2278896790" sldId="267"/>
        </pc:sldMkLst>
        <pc:spChg chg="mod">
          <ac:chgData name="Raji, Lukmon" userId="e0eacb11-e3cd-45f2-822c-68ccd699b297" providerId="ADAL" clId="{E77DA156-CF69-41F5-840F-366CE602D449}" dt="2026-02-22T22:50:45.657" v="377" actId="20577"/>
          <ac:spMkLst>
            <pc:docMk/>
            <pc:sldMk cId="2278896790" sldId="267"/>
            <ac:spMk id="2" creationId="{F0B329C7-1B4D-1C53-9954-C919BBB89274}"/>
          </ac:spMkLst>
        </pc:spChg>
      </pc:sldChg>
      <pc:sldMasterChg chg="addSldLayout">
        <pc:chgData name="Raji, Lukmon" userId="e0eacb11-e3cd-45f2-822c-68ccd699b297" providerId="ADAL" clId="{E77DA156-CF69-41F5-840F-366CE602D449}" dt="2026-02-21T00:59:19.806" v="0" actId="680"/>
        <pc:sldMasterMkLst>
          <pc:docMk/>
          <pc:sldMasterMk cId="739240282" sldId="2147483648"/>
        </pc:sldMasterMkLst>
        <pc:sldLayoutChg chg="add">
          <pc:chgData name="Raji, Lukmon" userId="e0eacb11-e3cd-45f2-822c-68ccd699b297" providerId="ADAL" clId="{E77DA156-CF69-41F5-840F-366CE602D449}" dt="2026-02-21T00:59:19.806" v="0" actId="680"/>
          <pc:sldLayoutMkLst>
            <pc:docMk/>
            <pc:sldMasterMk cId="739240282" sldId="2147483648"/>
            <pc:sldLayoutMk cId="4223115058" sldId="2147483649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9D58CC-DB29-8E5B-5BEC-5CA04ACCD2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1F434E7-463B-3FDE-4761-46B5982EE5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4223115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739240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7A36E7-F29D-AE3D-256E-1C6F77CEF28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HOK</a:t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80840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D4DC226-A604-4F99-0E72-21B2F2635CD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5C230AA-A6D4-D7F4-D183-79E9667A00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8372" y="207645"/>
            <a:ext cx="7915275" cy="59626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0B5398A-08B4-23FD-C021-9B21A03E84DA}"/>
              </a:ext>
            </a:extLst>
          </p:cNvPr>
          <p:cNvSpPr txBox="1"/>
          <p:nvPr/>
        </p:nvSpPr>
        <p:spPr>
          <a:xfrm>
            <a:off x="4735830" y="321945"/>
            <a:ext cx="344043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686TU GDF15</a:t>
            </a:r>
          </a:p>
          <a:p>
            <a:endParaRPr lang="en-US" sz="3200" dirty="0"/>
          </a:p>
          <a:p>
            <a:endParaRPr lang="en-US" sz="3200" dirty="0"/>
          </a:p>
          <a:p>
            <a:endParaRPr lang="en-US" sz="3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69A25B2-1AAE-AA91-09E9-83970BD986F9}"/>
              </a:ext>
            </a:extLst>
          </p:cNvPr>
          <p:cNvSpPr txBox="1"/>
          <p:nvPr/>
        </p:nvSpPr>
        <p:spPr>
          <a:xfrm>
            <a:off x="3757516" y="3846285"/>
            <a:ext cx="320335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 5.1       2.1      3.3      7.5       8.1      4.5     8.0</a:t>
            </a:r>
          </a:p>
          <a:p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BA9EECB-538C-726A-9724-7FB6625E34C6}"/>
              </a:ext>
            </a:extLst>
          </p:cNvPr>
          <p:cNvSpPr txBox="1"/>
          <p:nvPr/>
        </p:nvSpPr>
        <p:spPr>
          <a:xfrm>
            <a:off x="3964208" y="3188970"/>
            <a:ext cx="278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4 hours                48 hours </a:t>
            </a:r>
          </a:p>
        </p:txBody>
      </p:sp>
    </p:spTree>
    <p:extLst>
      <p:ext uri="{BB962C8B-B14F-4D97-AF65-F5344CB8AC3E}">
        <p14:creationId xmlns:p14="http://schemas.microsoft.com/office/powerpoint/2010/main" val="1733791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D402503-59C8-EEB8-76F7-BE81B204830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3C7FBBB-C5D0-7BB7-15F0-B46D6EFEC7A2}"/>
              </a:ext>
            </a:extLst>
          </p:cNvPr>
          <p:cNvSpPr txBox="1"/>
          <p:nvPr/>
        </p:nvSpPr>
        <p:spPr>
          <a:xfrm>
            <a:off x="4735830" y="321945"/>
            <a:ext cx="3440430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686TU ATF3</a:t>
            </a:r>
          </a:p>
          <a:p>
            <a:endParaRPr lang="en-US" sz="3200" dirty="0"/>
          </a:p>
          <a:p>
            <a:endParaRPr lang="en-US" sz="3200" dirty="0"/>
          </a:p>
          <a:p>
            <a:endParaRPr lang="en-US" sz="3200" dirty="0"/>
          </a:p>
          <a:p>
            <a:endParaRPr lang="en-US" sz="3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858D2E3-ACBF-842D-F9D2-D4DEFAFB7E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363" y="1038199"/>
            <a:ext cx="7131368" cy="537212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20A4825-7136-EF65-1657-E2CFD0E5380B}"/>
              </a:ext>
            </a:extLst>
          </p:cNvPr>
          <p:cNvSpPr txBox="1"/>
          <p:nvPr/>
        </p:nvSpPr>
        <p:spPr>
          <a:xfrm>
            <a:off x="3883246" y="3997077"/>
            <a:ext cx="320335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     2.9      1.8    3.7       2.9     3.1     1.6     3.6</a:t>
            </a:r>
          </a:p>
          <a:p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C89D727-B5A5-D2CE-3F18-20CB91637BFA}"/>
              </a:ext>
            </a:extLst>
          </p:cNvPr>
          <p:cNvSpPr txBox="1"/>
          <p:nvPr/>
        </p:nvSpPr>
        <p:spPr>
          <a:xfrm>
            <a:off x="4089938" y="3539596"/>
            <a:ext cx="278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4 hours                48 hours </a:t>
            </a:r>
          </a:p>
        </p:txBody>
      </p:sp>
    </p:spTree>
    <p:extLst>
      <p:ext uri="{BB962C8B-B14F-4D97-AF65-F5344CB8AC3E}">
        <p14:creationId xmlns:p14="http://schemas.microsoft.com/office/powerpoint/2010/main" val="145239163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0B22A5D-0B0B-DAAE-4D58-7A25667EB7D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64F784C-57FB-5943-3FF9-E9E7B1C868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363" y="1330949"/>
            <a:ext cx="6742748" cy="507937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5F105DE-D3FD-1808-9AFF-8758D28A4EB6}"/>
              </a:ext>
            </a:extLst>
          </p:cNvPr>
          <p:cNvSpPr txBox="1"/>
          <p:nvPr/>
        </p:nvSpPr>
        <p:spPr>
          <a:xfrm>
            <a:off x="5113020" y="426720"/>
            <a:ext cx="344043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686TU ACTIN</a:t>
            </a:r>
          </a:p>
          <a:p>
            <a:endParaRPr lang="en-US" sz="3200" dirty="0"/>
          </a:p>
          <a:p>
            <a:endParaRPr lang="en-US" sz="3200" dirty="0"/>
          </a:p>
          <a:p>
            <a:endParaRPr lang="en-US" sz="3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C027925-05B9-84F0-1C94-4870376CE1F5}"/>
              </a:ext>
            </a:extLst>
          </p:cNvPr>
          <p:cNvSpPr txBox="1"/>
          <p:nvPr/>
        </p:nvSpPr>
        <p:spPr>
          <a:xfrm>
            <a:off x="3866102" y="4660523"/>
            <a:ext cx="278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4 hours                48 hours </a:t>
            </a:r>
          </a:p>
        </p:txBody>
      </p:sp>
    </p:spTree>
    <p:extLst>
      <p:ext uri="{BB962C8B-B14F-4D97-AF65-F5344CB8AC3E}">
        <p14:creationId xmlns:p14="http://schemas.microsoft.com/office/powerpoint/2010/main" val="33708832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E0B068E-39CB-0D1E-BC15-66E4B783BA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3171" y="326567"/>
            <a:ext cx="7165658" cy="539795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6B1069D-7381-7A0B-32F7-161C63EB51AD}"/>
              </a:ext>
            </a:extLst>
          </p:cNvPr>
          <p:cNvSpPr txBox="1"/>
          <p:nvPr/>
        </p:nvSpPr>
        <p:spPr>
          <a:xfrm>
            <a:off x="5397722" y="272929"/>
            <a:ext cx="1828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Hok GDF 1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5CDE60E-0486-5234-5A5A-D4339C18FA46}"/>
              </a:ext>
            </a:extLst>
          </p:cNvPr>
          <p:cNvSpPr txBox="1"/>
          <p:nvPr/>
        </p:nvSpPr>
        <p:spPr>
          <a:xfrm>
            <a:off x="4483322" y="3901142"/>
            <a:ext cx="18288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 2.6      1.5      4.1</a:t>
            </a:r>
          </a:p>
          <a:p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71006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C5A8AF1-CA5F-7D29-DEE9-15BF6169A30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C6B9033-51A6-2A9B-5923-408FE2E25F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362" y="447675"/>
            <a:ext cx="7915275" cy="59626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E49A9D4-1E43-820F-8612-CE27EDDC529D}"/>
              </a:ext>
            </a:extLst>
          </p:cNvPr>
          <p:cNvSpPr txBox="1"/>
          <p:nvPr/>
        </p:nvSpPr>
        <p:spPr>
          <a:xfrm>
            <a:off x="4960620" y="274320"/>
            <a:ext cx="18288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Hok ATF3</a:t>
            </a:r>
          </a:p>
          <a:p>
            <a:endParaRPr lang="en-US" sz="3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15A846F-B1EC-3BA1-BCFE-2DF1E84B0EF0}"/>
              </a:ext>
            </a:extLst>
          </p:cNvPr>
          <p:cNvSpPr txBox="1"/>
          <p:nvPr/>
        </p:nvSpPr>
        <p:spPr>
          <a:xfrm>
            <a:off x="3408902" y="3824198"/>
            <a:ext cx="18288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   2.0      4.7       12.5</a:t>
            </a:r>
          </a:p>
          <a:p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95982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D6190B6-9CB5-CF75-882B-2B88E4F2F08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B1962BF-5206-FDE2-3C92-43A4B35FFB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362" y="447675"/>
            <a:ext cx="7915275" cy="59626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4B0BFFD-E67A-F7BF-1335-A7D685F57C40}"/>
              </a:ext>
            </a:extLst>
          </p:cNvPr>
          <p:cNvSpPr txBox="1"/>
          <p:nvPr/>
        </p:nvSpPr>
        <p:spPr>
          <a:xfrm>
            <a:off x="4960620" y="274320"/>
            <a:ext cx="344043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Hok Actin</a:t>
            </a:r>
          </a:p>
          <a:p>
            <a:endParaRPr lang="en-US" sz="3200" dirty="0"/>
          </a:p>
        </p:txBody>
      </p:sp>
    </p:spTree>
    <p:extLst>
      <p:ext uri="{BB962C8B-B14F-4D97-AF65-F5344CB8AC3E}">
        <p14:creationId xmlns:p14="http://schemas.microsoft.com/office/powerpoint/2010/main" val="32610074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4BD2D0-2904-24D0-56AC-1809BEF19BA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3A4D10-1FF4-D998-4BCD-E76DD3720A7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MSK</a:t>
            </a:r>
          </a:p>
        </p:txBody>
      </p:sp>
    </p:spTree>
    <p:extLst>
      <p:ext uri="{BB962C8B-B14F-4D97-AF65-F5344CB8AC3E}">
        <p14:creationId xmlns:p14="http://schemas.microsoft.com/office/powerpoint/2010/main" val="13624335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7BCE1F5-68C7-9D50-1763-3D8E9674BD4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AA1869F-CC2C-BBBB-C20A-932904288687}"/>
              </a:ext>
            </a:extLst>
          </p:cNvPr>
          <p:cNvSpPr txBox="1"/>
          <p:nvPr/>
        </p:nvSpPr>
        <p:spPr>
          <a:xfrm>
            <a:off x="4960620" y="274320"/>
            <a:ext cx="344043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MSK GDF</a:t>
            </a:r>
          </a:p>
          <a:p>
            <a:endParaRPr lang="en-US" sz="3200" dirty="0"/>
          </a:p>
          <a:p>
            <a:endParaRPr lang="en-US" sz="32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902D1AC-109F-B0F7-64CB-4B7E8C2410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363" y="1692583"/>
            <a:ext cx="6262688" cy="471774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1D368BD-3B29-5ABD-9F61-2AD75E562571}"/>
              </a:ext>
            </a:extLst>
          </p:cNvPr>
          <p:cNvSpPr txBox="1"/>
          <p:nvPr/>
        </p:nvSpPr>
        <p:spPr>
          <a:xfrm>
            <a:off x="3306032" y="3836009"/>
            <a:ext cx="27899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1.3     1.5    4.7    4.9     9.4    5.4   6.2</a:t>
            </a:r>
          </a:p>
          <a:p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259D8AB-1BA2-9C15-DB4C-3F9562C47A89}"/>
              </a:ext>
            </a:extLst>
          </p:cNvPr>
          <p:cNvSpPr txBox="1"/>
          <p:nvPr/>
        </p:nvSpPr>
        <p:spPr>
          <a:xfrm>
            <a:off x="3097530" y="3262243"/>
            <a:ext cx="278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4 hours                48 hours </a:t>
            </a:r>
          </a:p>
        </p:txBody>
      </p:sp>
    </p:spTree>
    <p:extLst>
      <p:ext uri="{BB962C8B-B14F-4D97-AF65-F5344CB8AC3E}">
        <p14:creationId xmlns:p14="http://schemas.microsoft.com/office/powerpoint/2010/main" val="27131488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66FBDC0-6BF3-0728-0C40-A4E40C7139A9}"/>
              </a:ext>
            </a:extLst>
          </p:cNvPr>
          <p:cNvSpPr txBox="1"/>
          <p:nvPr/>
        </p:nvSpPr>
        <p:spPr>
          <a:xfrm>
            <a:off x="5113020" y="426720"/>
            <a:ext cx="344043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MSK ATF3</a:t>
            </a:r>
          </a:p>
          <a:p>
            <a:endParaRPr lang="en-US" sz="3200" dirty="0"/>
          </a:p>
          <a:p>
            <a:endParaRPr lang="en-US" sz="3200" dirty="0"/>
          </a:p>
          <a:p>
            <a:endParaRPr lang="en-US" sz="3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5DE9FEE-D6AF-6D49-421D-2EBC229458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363" y="1210405"/>
            <a:ext cx="6902768" cy="519991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1B928ED-52C9-ADD1-597B-BD6CF53B0F72}"/>
              </a:ext>
            </a:extLst>
          </p:cNvPr>
          <p:cNvSpPr txBox="1"/>
          <p:nvPr/>
        </p:nvSpPr>
        <p:spPr>
          <a:xfrm>
            <a:off x="3568922" y="2998113"/>
            <a:ext cx="27899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2.6     1.9    3.3       1.1      3.1    1.6   1.3</a:t>
            </a:r>
          </a:p>
          <a:p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A8BB45E-6997-CD5A-5A7C-15E81ACED050}"/>
              </a:ext>
            </a:extLst>
          </p:cNvPr>
          <p:cNvSpPr txBox="1"/>
          <p:nvPr/>
        </p:nvSpPr>
        <p:spPr>
          <a:xfrm>
            <a:off x="3568922" y="2488823"/>
            <a:ext cx="278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4 hours                48 hours </a:t>
            </a:r>
          </a:p>
        </p:txBody>
      </p:sp>
    </p:spTree>
    <p:extLst>
      <p:ext uri="{BB962C8B-B14F-4D97-AF65-F5344CB8AC3E}">
        <p14:creationId xmlns:p14="http://schemas.microsoft.com/office/powerpoint/2010/main" val="21259851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A376964-ED26-C108-4EEF-1BD6DD74568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A1BA7BD-6FD4-0F8C-FC87-9E119A71C791}"/>
              </a:ext>
            </a:extLst>
          </p:cNvPr>
          <p:cNvSpPr txBox="1"/>
          <p:nvPr/>
        </p:nvSpPr>
        <p:spPr>
          <a:xfrm>
            <a:off x="4960620" y="274320"/>
            <a:ext cx="344043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MSK Actin</a:t>
            </a:r>
          </a:p>
          <a:p>
            <a:endParaRPr lang="en-US" sz="3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254F9F6-758B-7302-57D4-BFAC0229FF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9923" y="1977633"/>
            <a:ext cx="5611178" cy="422695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33B0C17-7FE4-31DE-6CF7-7D24B68C55B2}"/>
              </a:ext>
            </a:extLst>
          </p:cNvPr>
          <p:cNvSpPr txBox="1"/>
          <p:nvPr/>
        </p:nvSpPr>
        <p:spPr>
          <a:xfrm>
            <a:off x="4434840" y="4222363"/>
            <a:ext cx="278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4 hours            48 hours </a:t>
            </a:r>
          </a:p>
        </p:txBody>
      </p:sp>
    </p:spTree>
    <p:extLst>
      <p:ext uri="{BB962C8B-B14F-4D97-AF65-F5344CB8AC3E}">
        <p14:creationId xmlns:p14="http://schemas.microsoft.com/office/powerpoint/2010/main" val="18343254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A8AE4E6-62E6-8224-EF00-57CD88F5822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B329C7-1B4D-1C53-9954-C919BBB8927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686TU</a:t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88967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8</TotalTime>
  <Words>89</Words>
  <Application>Microsoft Office PowerPoint</Application>
  <PresentationFormat>Widescreen</PresentationFormat>
  <Paragraphs>29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ptos</vt:lpstr>
      <vt:lpstr>Aptos Display</vt:lpstr>
      <vt:lpstr>Arial</vt:lpstr>
      <vt:lpstr>Times New Roman</vt:lpstr>
      <vt:lpstr>Office Theme</vt:lpstr>
      <vt:lpstr>HOK </vt:lpstr>
      <vt:lpstr>PowerPoint Presentation</vt:lpstr>
      <vt:lpstr>PowerPoint Presentation</vt:lpstr>
      <vt:lpstr>PowerPoint Presentation</vt:lpstr>
      <vt:lpstr>MSK</vt:lpstr>
      <vt:lpstr>PowerPoint Presentation</vt:lpstr>
      <vt:lpstr>PowerPoint Presentation</vt:lpstr>
      <vt:lpstr>PowerPoint Presentation</vt:lpstr>
      <vt:lpstr>686TU 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OK </dc:title>
  <dc:creator>Raji, Lukmon</dc:creator>
  <cp:lastModifiedBy>MDPI</cp:lastModifiedBy>
  <cp:revision>1</cp:revision>
  <dcterms:created xsi:type="dcterms:W3CDTF">2026-02-21T00:59:16Z</dcterms:created>
  <dcterms:modified xsi:type="dcterms:W3CDTF">2026-03-28T07:10:49Z</dcterms:modified>
</cp:coreProperties>
</file>